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2" autoAdjust="0"/>
    <p:restoredTop sz="94660"/>
  </p:normalViewPr>
  <p:slideViewPr>
    <p:cSldViewPr snapToGrid="0">
      <p:cViewPr varScale="1">
        <p:scale>
          <a:sx n="63" d="100"/>
          <a:sy n="63" d="100"/>
        </p:scale>
        <p:origin x="76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249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560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286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06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547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149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43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0844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063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537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876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3008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4BA61D-40FB-3E67-3644-AADACF8495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91160" y="4632961"/>
            <a:ext cx="11506200" cy="2056448"/>
          </a:xfrm>
        </p:spPr>
        <p:txBody>
          <a:bodyPr>
            <a:normAutofit fontScale="90000"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br>
              <a:rPr lang="en-US" sz="1800" b="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</a:br>
            <a:r>
              <a:rPr lang="en-US" sz="1800" b="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4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wo examples of transcutaneous excision of typical lower eyelid WGDCs.</a:t>
            </a:r>
            <a:br>
              <a:rPr lang="en-US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</a:br>
            <a:r>
              <a:rPr lang="en-US" sz="18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,B </a:t>
            </a:r>
            <a:r>
              <a:rPr lang="en-US" sz="1800" b="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ntraoperative and postoperative pictures of a 4-year-old girl having right lower eyelid WGDC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,D </a:t>
            </a:r>
            <a:r>
              <a:rPr lang="en-US" sz="1800" b="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re- and early postoperative appearance of a 42-year-old women having right lower eyelid WGDC.</a:t>
            </a:r>
            <a:br>
              <a:rPr lang="en-US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</a:br>
            <a:endParaRPr lang="en-US" dirty="0"/>
          </a:p>
        </p:txBody>
      </p:sp>
      <p:pic>
        <p:nvPicPr>
          <p:cNvPr id="5" name="Content Placeholder 4" descr="Close-up of several photos of a person's face&#10;&#10;Description automatically generated">
            <a:extLst>
              <a:ext uri="{FF2B5EF4-FFF2-40B4-BE49-F238E27FC236}">
                <a16:creationId xmlns:a16="http://schemas.microsoft.com/office/drawing/2014/main" id="{9F0DDFEC-6640-172C-91D7-353AEA087D9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0542" y="168592"/>
            <a:ext cx="7720835" cy="4351338"/>
          </a:xfrm>
        </p:spPr>
      </p:pic>
    </p:spTree>
    <p:extLst>
      <p:ext uri="{BB962C8B-B14F-4D97-AF65-F5344CB8AC3E}">
        <p14:creationId xmlns:p14="http://schemas.microsoft.com/office/powerpoint/2010/main" val="2239053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 Supplementary figure 4. Two examples of transcutaneous excision of typical lower eyelid WGDCs. A,B Intraoperative and postoperative pictures of a 4-year-old girl having right lower eyelid WGDC. C,D Pre- and early postoperative appearance of a 42-year-old women having right lower eyelid WGDC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S Presentation</dc:title>
  <dc:creator>mosta</dc:creator>
  <cp:lastModifiedBy>Mahmoud Mohamed Diab</cp:lastModifiedBy>
  <cp:revision>1</cp:revision>
  <dcterms:created xsi:type="dcterms:W3CDTF">2023-12-18T05:02:17Z</dcterms:created>
  <dcterms:modified xsi:type="dcterms:W3CDTF">2023-12-18T05:04:02Z</dcterms:modified>
</cp:coreProperties>
</file>